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41" autoAdjust="0"/>
    <p:restoredTop sz="94048" autoAdjust="0"/>
  </p:normalViewPr>
  <p:slideViewPr>
    <p:cSldViewPr snapToGrid="0" snapToObjects="1">
      <p:cViewPr varScale="1">
        <p:scale>
          <a:sx n="69" d="100"/>
          <a:sy n="69" d="100"/>
        </p:scale>
        <p:origin x="31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7C95DF1-B339-442B-A66D-08441AEBFC1C}"/>
              </a:ext>
            </a:extLst>
          </p:cNvPr>
          <p:cNvSpPr/>
          <p:nvPr/>
        </p:nvSpPr>
        <p:spPr>
          <a:xfrm>
            <a:off x="165028" y="7306015"/>
            <a:ext cx="648515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CA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: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imum likelihood amino acid phylogeny of Bee macula-like virus replicase from hornets (243 aa, LG+I+G+F model). GenBank accessions are shown in Table S2. </a:t>
            </a:r>
            <a:endParaRPr lang="fr-FR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397FFB23-9CA2-4E93-ADBD-95E15C6165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028" y="698532"/>
            <a:ext cx="6858000" cy="6607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2188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3</TotalTime>
  <Words>36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49</cp:revision>
  <dcterms:created xsi:type="dcterms:W3CDTF">2019-01-23T12:04:28Z</dcterms:created>
  <dcterms:modified xsi:type="dcterms:W3CDTF">2019-07-19T16:40:19Z</dcterms:modified>
</cp:coreProperties>
</file>